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96641-EF03-4241-98B4-182F60A7C5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26593-0300-487C-B313-797F23B0D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8D499-59BB-44FE-A761-36520E9034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D8403-21E1-4610-B920-E83E07EAA3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C213F-8A27-43FB-AE03-F26E3409F5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A679E-751B-4285-96B7-82ED1411F7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B7FCF-B158-4B8D-A56D-E04B4F2893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092F6-FD1B-456F-AA4C-3FB6A46AC8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00B11-B97C-44A3-ACD2-F956083C5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96438-5EDD-409A-BD82-BB44324E5F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F6A75-E95C-44EC-ABEC-57F7ECDC8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98EBB-1049-44FB-923C-E15B8B92A6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6ECCCF9-DEA8-4233-86ED-E42AEDDDE59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90E2FB-497E-4576-B0CC-2FF09CDC85D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14"/>
          <p:cNvGrpSpPr/>
          <p:nvPr/>
        </p:nvGrpSpPr>
        <p:grpSpPr>
          <a:xfrm>
            <a:off x="1744560" y="306360"/>
            <a:ext cx="5935680" cy="6477120"/>
            <a:chOff x="1744560" y="306360"/>
            <a:chExt cx="5935680" cy="6477120"/>
          </a:xfrm>
        </p:grpSpPr>
        <p:pic>
          <p:nvPicPr>
            <p:cNvPr id="42" name="Picture 4" descr=""/>
            <p:cNvPicPr/>
            <p:nvPr/>
          </p:nvPicPr>
          <p:blipFill>
            <a:blip r:embed="rId1"/>
            <a:stretch/>
          </p:blipFill>
          <p:spPr>
            <a:xfrm>
              <a:off x="1744560" y="306360"/>
              <a:ext cx="5935680" cy="647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Oval 4"/>
            <p:cNvSpPr/>
            <p:nvPr/>
          </p:nvSpPr>
          <p:spPr>
            <a:xfrm>
              <a:off x="4071960" y="5247000"/>
              <a:ext cx="230040" cy="230040"/>
            </a:xfrm>
            <a:prstGeom prst="ellipse">
              <a:avLst/>
            </a:prstGeom>
            <a:solidFill>
              <a:srgbClr val="e46c0a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Oval 8"/>
            <p:cNvSpPr/>
            <p:nvPr/>
          </p:nvSpPr>
          <p:spPr>
            <a:xfrm>
              <a:off x="2544480" y="3164040"/>
              <a:ext cx="230040" cy="230040"/>
            </a:xfrm>
            <a:prstGeom prst="ellipse">
              <a:avLst/>
            </a:prstGeom>
            <a:solidFill>
              <a:srgbClr val="e46c0a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Oval 9"/>
            <p:cNvSpPr/>
            <p:nvPr/>
          </p:nvSpPr>
          <p:spPr>
            <a:xfrm>
              <a:off x="4143240" y="2890800"/>
              <a:ext cx="230040" cy="230040"/>
            </a:xfrm>
            <a:prstGeom prst="ellipse">
              <a:avLst/>
            </a:prstGeom>
            <a:solidFill>
              <a:srgbClr val="e46c0a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Oval 11"/>
            <p:cNvSpPr/>
            <p:nvPr/>
          </p:nvSpPr>
          <p:spPr>
            <a:xfrm>
              <a:off x="6740640" y="2535120"/>
              <a:ext cx="230040" cy="231480"/>
            </a:xfrm>
            <a:prstGeom prst="ellipse">
              <a:avLst/>
            </a:prstGeom>
            <a:solidFill>
              <a:srgbClr val="e46c0a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Oval 15"/>
            <p:cNvSpPr/>
            <p:nvPr/>
          </p:nvSpPr>
          <p:spPr>
            <a:xfrm>
              <a:off x="3547800" y="2044800"/>
              <a:ext cx="230040" cy="230040"/>
            </a:xfrm>
            <a:prstGeom prst="ellipse">
              <a:avLst/>
            </a:prstGeom>
            <a:solidFill>
              <a:srgbClr val="e46c0a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03"/>
            <p:cNvSpPr/>
            <p:nvPr/>
          </p:nvSpPr>
          <p:spPr>
            <a:xfrm>
              <a:off x="4663440" y="1439280"/>
              <a:ext cx="2066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: Delhi, 2: Panna, 3: Nadia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: Chennai, 5: Kamru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86"/>
            <p:cNvSpPr/>
            <p:nvPr/>
          </p:nvSpPr>
          <p:spPr>
            <a:xfrm>
              <a:off x="3531960" y="200700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99"/>
            <p:cNvSpPr/>
            <p:nvPr/>
          </p:nvSpPr>
          <p:spPr>
            <a:xfrm>
              <a:off x="4128840" y="284544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00"/>
            <p:cNvSpPr/>
            <p:nvPr/>
          </p:nvSpPr>
          <p:spPr>
            <a:xfrm>
              <a:off x="2528640" y="312480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01"/>
            <p:cNvSpPr/>
            <p:nvPr/>
          </p:nvSpPr>
          <p:spPr>
            <a:xfrm>
              <a:off x="4052520" y="522036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02"/>
            <p:cNvSpPr/>
            <p:nvPr/>
          </p:nvSpPr>
          <p:spPr>
            <a:xfrm>
              <a:off x="6719760" y="250236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TextBox 121"/>
          <p:cNvSpPr/>
          <p:nvPr/>
        </p:nvSpPr>
        <p:spPr>
          <a:xfrm>
            <a:off x="1575720" y="6438960"/>
            <a:ext cx="433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: Map of India showing loca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vivax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ampling si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7T06:49:37Z</dcterms:created>
  <dc:creator>Surendra Kumar  Prajapati</dc:creator>
  <dc:description/>
  <dc:language>en-US</dc:language>
  <cp:lastModifiedBy>Surendra Kumar  Prajapati</cp:lastModifiedBy>
  <dcterms:modified xsi:type="dcterms:W3CDTF">2013-08-20T15:16:00Z</dcterms:modified>
  <cp:revision>15</cp:revision>
  <dc:subject/>
  <dc:title>Slide 1</dc:title>
</cp:coreProperties>
</file>